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99000" y="323528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4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Ultrasound placental measurements at 21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99000" y="614611"/>
          <a:ext cx="6660000" cy="952500"/>
        </p:xfrm>
        <a:graphic>
          <a:graphicData uri="http://schemas.openxmlformats.org/drawingml/2006/table">
            <a:tbl>
              <a:tblPr/>
              <a:tblGrid>
                <a:gridCol w="1037923"/>
                <a:gridCol w="345974"/>
                <a:gridCol w="345974"/>
                <a:gridCol w="1389372"/>
                <a:gridCol w="1348861"/>
                <a:gridCol w="590127"/>
                <a:gridCol w="1011646"/>
                <a:gridCol w="590123"/>
              </a:tblGrid>
              <a:tr h="381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ria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f </a:t>
                      </a:r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acenta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dian</a:t>
                      </a:r>
                      <a:r>
                        <a:rPr lang="fr-FR" sz="1000" b="1" i="0" u="none" strike="noStrike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Q1; Q3]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am -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jus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nea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mod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β 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olume (mm</a:t>
                      </a:r>
                      <a:r>
                        <a:rPr lang="fr-FR" sz="1000" b="0" i="0" u="none" strike="noStrike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056 [6.397; 7.618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196 [6.743; 7.698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0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0.642;0.58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9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an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Gre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1.10 [40.17; 42.67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0.56 [38.04; 41.80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2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2.82;2.345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99000" y="1574731"/>
            <a:ext cx="6660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ean Grey represents the density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issu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of interest. All data are expressed as median[Q1;Q3]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r-FR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9</TotalTime>
  <Words>96</Words>
  <Application>Microsoft Office PowerPoint</Application>
  <PresentationFormat>Affichage à l'écran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61</cp:revision>
  <dcterms:created xsi:type="dcterms:W3CDTF">2015-02-24T15:36:47Z</dcterms:created>
  <dcterms:modified xsi:type="dcterms:W3CDTF">2016-02-08T10:29:38Z</dcterms:modified>
</cp:coreProperties>
</file>